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handoutMasterIdLst>
    <p:handoutMasterId r:id="rId6"/>
  </p:handoutMasterIdLst>
  <p:sldIdLst>
    <p:sldId id="273" r:id="rId2"/>
    <p:sldId id="271" r:id="rId3"/>
    <p:sldId id="269" r:id="rId4"/>
  </p:sldIdLst>
  <p:sldSz cx="6858000" cy="9144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7753" autoAdjust="0"/>
    <p:restoredTop sz="94358" autoAdjust="0"/>
  </p:normalViewPr>
  <p:slideViewPr>
    <p:cSldViewPr snapToGrid="0">
      <p:cViewPr varScale="1">
        <p:scale>
          <a:sx n="53" d="100"/>
          <a:sy n="53" d="100"/>
        </p:scale>
        <p:origin x="259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-166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1D9180-1093-4C66-A283-A3877C4DF989}" type="datetimeFigureOut">
              <a:rPr lang="en-GB" smtClean="0"/>
              <a:t>27/06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3A2439-01DF-4410-A829-1419B0BC55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924521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8DCDA69-7724-4A38-A652-1D8BF169AB46}" type="datetimeFigureOut">
              <a:rPr lang="en-GB" smtClean="0"/>
              <a:t>27/06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73D406-494E-4AC5-BF40-7C85CD6381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85293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0F916-1267-46ED-A649-055CC4727A37}" type="datetimeFigureOut">
              <a:rPr lang="en-GB" smtClean="0"/>
              <a:t>27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6E396-2C17-4FCA-89E8-D804FF1E6D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44001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0F916-1267-46ED-A649-055CC4727A37}" type="datetimeFigureOut">
              <a:rPr lang="en-GB" smtClean="0"/>
              <a:t>27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6E396-2C17-4FCA-89E8-D804FF1E6D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18797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0F916-1267-46ED-A649-055CC4727A37}" type="datetimeFigureOut">
              <a:rPr lang="en-GB" smtClean="0"/>
              <a:t>27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6E396-2C17-4FCA-89E8-D804FF1E6D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53638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0F916-1267-46ED-A649-055CC4727A37}" type="datetimeFigureOut">
              <a:rPr lang="en-GB" smtClean="0"/>
              <a:t>27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6E396-2C17-4FCA-89E8-D804FF1E6D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87471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0F916-1267-46ED-A649-055CC4727A37}" type="datetimeFigureOut">
              <a:rPr lang="en-GB" smtClean="0"/>
              <a:t>27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6E396-2C17-4FCA-89E8-D804FF1E6D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85321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0F916-1267-46ED-A649-055CC4727A37}" type="datetimeFigureOut">
              <a:rPr lang="en-GB" smtClean="0"/>
              <a:t>27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6E396-2C17-4FCA-89E8-D804FF1E6D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69009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0F916-1267-46ED-A649-055CC4727A37}" type="datetimeFigureOut">
              <a:rPr lang="en-GB" smtClean="0"/>
              <a:t>27/06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6E396-2C17-4FCA-89E8-D804FF1E6D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53999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0F916-1267-46ED-A649-055CC4727A37}" type="datetimeFigureOut">
              <a:rPr lang="en-GB" smtClean="0"/>
              <a:t>27/06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6E396-2C17-4FCA-89E8-D804FF1E6D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30748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0F916-1267-46ED-A649-055CC4727A37}" type="datetimeFigureOut">
              <a:rPr lang="en-GB" smtClean="0"/>
              <a:t>27/06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6E396-2C17-4FCA-89E8-D804FF1E6D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76291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0F916-1267-46ED-A649-055CC4727A37}" type="datetimeFigureOut">
              <a:rPr lang="en-GB" smtClean="0"/>
              <a:t>27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6E396-2C17-4FCA-89E8-D804FF1E6D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55039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0F916-1267-46ED-A649-055CC4727A37}" type="datetimeFigureOut">
              <a:rPr lang="en-GB" smtClean="0"/>
              <a:t>27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6E396-2C17-4FCA-89E8-D804FF1E6D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51195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D0F916-1267-46ED-A649-055CC4727A37}" type="datetimeFigureOut">
              <a:rPr lang="en-GB" smtClean="0"/>
              <a:t>27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D6E396-2C17-4FCA-89E8-D804FF1E6D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06610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E16A507A-C47A-4BE6-93F3-90A36F96B55C}"/>
              </a:ext>
            </a:extLst>
          </p:cNvPr>
          <p:cNvSpPr txBox="1"/>
          <p:nvPr/>
        </p:nvSpPr>
        <p:spPr>
          <a:xfrm>
            <a:off x="84003" y="194641"/>
            <a:ext cx="3235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Figure 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F90F5DA0-2D8E-39FB-447E-8369C0425B72}"/>
              </a:ext>
            </a:extLst>
          </p:cNvPr>
          <p:cNvSpPr txBox="1"/>
          <p:nvPr/>
        </p:nvSpPr>
        <p:spPr>
          <a:xfrm>
            <a:off x="1261595" y="4379393"/>
            <a:ext cx="1127961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 err="1"/>
              <a:t>CysB</a:t>
            </a:r>
            <a:r>
              <a:rPr lang="en-US" sz="1350" dirty="0"/>
              <a:t>(88-324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A06F4C2D-A40D-CE0F-E00F-EB995BE52260}"/>
              </a:ext>
            </a:extLst>
          </p:cNvPr>
          <p:cNvSpPr txBox="1"/>
          <p:nvPr/>
        </p:nvSpPr>
        <p:spPr>
          <a:xfrm>
            <a:off x="4790509" y="4309819"/>
            <a:ext cx="45717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dirty="0" err="1"/>
              <a:t>LacI</a:t>
            </a:r>
            <a:endParaRPr lang="en-US" sz="1350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19671" y="1853154"/>
            <a:ext cx="3405542" cy="2493283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43216"/>
            <a:ext cx="3459844" cy="253303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DB08B9ED-4869-D7E6-BF2E-60676C0EE06D}"/>
              </a:ext>
            </a:extLst>
          </p:cNvPr>
          <p:cNvSpPr txBox="1"/>
          <p:nvPr/>
        </p:nvSpPr>
        <p:spPr>
          <a:xfrm>
            <a:off x="339213" y="1474839"/>
            <a:ext cx="309716" cy="3683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9BFE9430-C7A8-4A76-B4E6-565FA71E7317}"/>
              </a:ext>
            </a:extLst>
          </p:cNvPr>
          <p:cNvSpPr txBox="1"/>
          <p:nvPr/>
        </p:nvSpPr>
        <p:spPr>
          <a:xfrm>
            <a:off x="3787146" y="1474838"/>
            <a:ext cx="330619" cy="3683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60218" y="5583381"/>
            <a:ext cx="6237143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Supplementary Figure 1. Alternative symmetry in the effector binding domains of CysB and Lac Repressor. </a:t>
            </a:r>
            <a:r>
              <a:rPr lang="en-GB" sz="1600" dirty="0"/>
              <a:t>Ribbon representations of (</a:t>
            </a:r>
            <a:r>
              <a:rPr lang="en-GB" sz="1600" b="1" dirty="0"/>
              <a:t>A</a:t>
            </a:r>
            <a:r>
              <a:rPr lang="en-GB" sz="1600" dirty="0"/>
              <a:t>) the CysB(88-324) dimer (PDB ID: 1AL3) with bound sulphate species and (</a:t>
            </a:r>
            <a:r>
              <a:rPr lang="en-GB" sz="1600" b="1" dirty="0"/>
              <a:t>B</a:t>
            </a:r>
            <a:r>
              <a:rPr lang="en-GB" sz="1600" dirty="0"/>
              <a:t>) a </a:t>
            </a:r>
            <a:r>
              <a:rPr lang="en-GB" sz="1600" dirty="0" err="1"/>
              <a:t>LacI</a:t>
            </a:r>
            <a:r>
              <a:rPr lang="en-GB" sz="1600" dirty="0"/>
              <a:t>(62-330) dimer (PDB ID: 2P9H) with bound isopropyl b-D </a:t>
            </a:r>
            <a:r>
              <a:rPr lang="en-GB" sz="1600" dirty="0" err="1"/>
              <a:t>galactoside</a:t>
            </a:r>
            <a:r>
              <a:rPr lang="en-GB" sz="1600" dirty="0"/>
              <a:t> (IPTG). In each case the colouring is by chain with the ligands in cylinder representation. The N-termini (N) of the chains are labelled and the different directions of the 2-fold symmetry axes are apparent</a:t>
            </a:r>
          </a:p>
        </p:txBody>
      </p:sp>
    </p:spTree>
    <p:extLst>
      <p:ext uri="{BB962C8B-B14F-4D97-AF65-F5344CB8AC3E}">
        <p14:creationId xmlns:p14="http://schemas.microsoft.com/office/powerpoint/2010/main" val="41148239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9353" y="1190052"/>
            <a:ext cx="4923663" cy="182429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88985" y="6344672"/>
            <a:ext cx="5926657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Supplementary Figure </a:t>
            </a:r>
            <a:r>
              <a:rPr lang="en-GB" sz="1600" b="1" dirty="0" smtClean="0"/>
              <a:t>2 NAS </a:t>
            </a:r>
            <a:r>
              <a:rPr lang="en-GB" sz="1600" b="1" dirty="0"/>
              <a:t>Binding Site.  </a:t>
            </a:r>
            <a:r>
              <a:rPr lang="en-GB" sz="1600" dirty="0"/>
              <a:t>Stereo views of (upper panel) 2mF</a:t>
            </a:r>
            <a:r>
              <a:rPr lang="en-GB" sz="1600" baseline="-25000" dirty="0"/>
              <a:t>o</a:t>
            </a:r>
            <a:r>
              <a:rPr lang="en-GB" sz="1600" dirty="0"/>
              <a:t> – </a:t>
            </a:r>
            <a:r>
              <a:rPr lang="en-GB" sz="1600" dirty="0" err="1"/>
              <a:t>dF</a:t>
            </a:r>
            <a:r>
              <a:rPr lang="en-GB" sz="1600" baseline="-25000" dirty="0" err="1"/>
              <a:t>c</a:t>
            </a:r>
            <a:r>
              <a:rPr lang="en-GB" sz="1600" dirty="0"/>
              <a:t> map contoured at 1 sigma and displayed on the coordinates of the </a:t>
            </a:r>
            <a:r>
              <a:rPr lang="en-GB" sz="1600" i="1" dirty="0"/>
              <a:t>N</a:t>
            </a:r>
            <a:r>
              <a:rPr lang="en-GB" sz="1600" dirty="0"/>
              <a:t>-acetylserine ligand from the A molecule of the asymmetric unit of the </a:t>
            </a:r>
            <a:r>
              <a:rPr lang="en-GB" sz="1600" i="1" dirty="0"/>
              <a:t>H</a:t>
            </a:r>
            <a:r>
              <a:rPr lang="en-GB" sz="1600" dirty="0"/>
              <a:t>32 unit cell and (lower panel) the interactions of the </a:t>
            </a:r>
            <a:r>
              <a:rPr lang="en-GB" sz="1600" i="1" dirty="0"/>
              <a:t>N</a:t>
            </a:r>
            <a:r>
              <a:rPr lang="en-GB" sz="1600" dirty="0"/>
              <a:t>-acetylserine ligand with the surrounding protein</a:t>
            </a:r>
            <a:r>
              <a:rPr lang="en-GB" dirty="0"/>
              <a:t>.</a:t>
            </a:r>
            <a:endParaRPr lang="en-GB" sz="1200" dirty="0"/>
          </a:p>
        </p:txBody>
      </p:sp>
      <p:sp>
        <p:nvSpPr>
          <p:cNvPr id="5" name="TextBox 4"/>
          <p:cNvSpPr txBox="1"/>
          <p:nvPr/>
        </p:nvSpPr>
        <p:spPr>
          <a:xfrm>
            <a:off x="82284" y="273050"/>
            <a:ext cx="29241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Figure 2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9875" y="3631262"/>
            <a:ext cx="4584879" cy="22257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79450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1955" y="1578657"/>
            <a:ext cx="5743473" cy="227290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29209" y="488950"/>
            <a:ext cx="34452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Figure 3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04800" y="5833196"/>
            <a:ext cx="6172200" cy="13542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Supplementary Figure 3. Sulphate Binding Site in CysB(88-324).  </a:t>
            </a:r>
            <a:r>
              <a:rPr lang="en-GB" sz="1600" dirty="0"/>
              <a:t>Stereo view of the bound sulphate (cylinder) and surrounding protein (ball-and-stick) in the CysB(88-324)-SO</a:t>
            </a:r>
            <a:r>
              <a:rPr lang="en-GB" sz="1600" baseline="-25000" dirty="0"/>
              <a:t>4</a:t>
            </a:r>
            <a:r>
              <a:rPr lang="en-GB" sz="1600" baseline="30000" dirty="0"/>
              <a:t>2-</a:t>
            </a:r>
            <a:r>
              <a:rPr lang="en-GB" sz="1600" dirty="0"/>
              <a:t> complex. W denotes a water molecule. Dashed lines indicate polar interactions. </a:t>
            </a: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658385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381</TotalTime>
  <Words>213</Words>
  <Application>Microsoft Office PowerPoint</Application>
  <PresentationFormat>On-screen Show (4:3)</PresentationFormat>
  <Paragraphs>10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jw11</dc:creator>
  <cp:lastModifiedBy>Sathish Anandaraj</cp:lastModifiedBy>
  <cp:revision>157</cp:revision>
  <cp:lastPrinted>2024-05-03T12:51:44Z</cp:lastPrinted>
  <dcterms:created xsi:type="dcterms:W3CDTF">2021-12-08T15:49:30Z</dcterms:created>
  <dcterms:modified xsi:type="dcterms:W3CDTF">2024-06-27T08:06:40Z</dcterms:modified>
</cp:coreProperties>
</file>